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4660"/>
  </p:normalViewPr>
  <p:slideViewPr>
    <p:cSldViewPr>
      <p:cViewPr varScale="1">
        <p:scale>
          <a:sx n="86" d="100"/>
          <a:sy n="86" d="100"/>
        </p:scale>
        <p:origin x="1354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1910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13391" y="41910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/>
              <a:t>Quantitative </a:t>
            </a:r>
            <a:r>
              <a:rPr lang="en-US" altLang="en-US" sz="3600" baseline="30000" dirty="0"/>
              <a:t>99m</a:t>
            </a:r>
            <a:r>
              <a:rPr lang="en-US" altLang="en-US" sz="3600" dirty="0"/>
              <a:t>Tc-DPD-SPECT/CT assessment of cardiac amyloidosis</a:t>
            </a: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ukas Kessler, Pedro Fragoso Costa, David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rsting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Walter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entzen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anuel Weber, Peter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üdike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lexander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rpinteiro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ara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ubari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Tim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genacker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reas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imm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enush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ssaf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Ken Herrmann, Maria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pathanasiou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Christoph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ischpler</a:t>
            </a:r>
            <a:endParaRPr lang="en-US" sz="9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iversity Hospital Essen, University of Duisburg-Essen, Germany</a:t>
            </a:r>
            <a:endParaRPr lang="en-US" sz="9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fik 4" descr="Ein Bild, das Mann, Person, Schlips, Anzug enthält.&#10;&#10;Automatisch generierte Beschreibung">
            <a:extLst>
              <a:ext uri="{FF2B5EF4-FFF2-40B4-BE49-F238E27FC236}">
                <a16:creationId xmlns:a16="http://schemas.microsoft.com/office/drawing/2014/main" id="{71BF7978-1B55-453D-B060-F5607DB25A2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71" r="10519"/>
          <a:stretch/>
        </p:blipFill>
        <p:spPr>
          <a:xfrm>
            <a:off x="1496236" y="4215869"/>
            <a:ext cx="1415509" cy="147426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A0991472-812A-458F-B528-815A3B07E13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519" t="33587" r="27468" b="40253"/>
          <a:stretch/>
        </p:blipFill>
        <p:spPr>
          <a:xfrm>
            <a:off x="5714217" y="4694609"/>
            <a:ext cx="1830366" cy="480859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200" dirty="0"/>
              <a:t>1- Cardiac amyloidosis is underdiagnosed cause for heart failure</a:t>
            </a:r>
          </a:p>
          <a:p>
            <a:pPr marL="0" indent="0">
              <a:buNone/>
            </a:pPr>
            <a:endParaRPr lang="en-US" altLang="en-US" sz="2200" dirty="0"/>
          </a:p>
          <a:p>
            <a:pPr marL="0" indent="0">
              <a:buNone/>
            </a:pPr>
            <a:r>
              <a:rPr lang="en-US" altLang="en-US" sz="2200" dirty="0"/>
              <a:t>2- Cardiac ATTR amyloidosis can be detected by bone scintigraphy with high sensitivity and specificity </a:t>
            </a:r>
          </a:p>
          <a:p>
            <a:pPr marL="0" indent="0">
              <a:buNone/>
            </a:pPr>
            <a:endParaRPr lang="en-US" altLang="en-US" sz="2200" dirty="0"/>
          </a:p>
          <a:p>
            <a:pPr marL="0" indent="0">
              <a:buNone/>
            </a:pPr>
            <a:r>
              <a:rPr lang="en-US" altLang="en-US" sz="2200" dirty="0"/>
              <a:t>3- Quantitative SPECT/CT with bone seeking radiotracers could potentially increase the diagnostic value of this method. But so far only few approaches have been evaluated</a:t>
            </a:r>
          </a:p>
          <a:p>
            <a:pPr marL="0" indent="0">
              <a:buNone/>
            </a:pPr>
            <a:endParaRPr lang="en-US" altLang="en-US" sz="2200" dirty="0"/>
          </a:p>
          <a:p>
            <a:pPr marL="0" indent="0">
              <a:buNone/>
            </a:pPr>
            <a:r>
              <a:rPr lang="en-US" altLang="en-US" sz="2200" dirty="0"/>
              <a:t>4- We demonstrated an accessible quantification method for 99mTc-DPD SPECT/CT in patients with suspected cardiac amyloidosis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(</a:t>
            </a:r>
            <a:r>
              <a:rPr lang="en-US" altLang="en-US" sz="20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/>
              <a:t>retrospective, single-center.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1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(one sentence summarizing included and/or excluded subjects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/>
              <a:t>Patients with suspected cardiac amyloidosis (CA) undergoing 99mTc-DPD-SPECT/CT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1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/>
              <a:t>Significantly higher SUVmax of patients with CA vs. no CA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/>
              <a:t>Correlation with </a:t>
            </a:r>
            <a:r>
              <a:rPr lang="en-US" altLang="en-US" sz="1400" dirty="0" err="1"/>
              <a:t>Perugini</a:t>
            </a:r>
            <a:r>
              <a:rPr lang="en-US" altLang="en-US" sz="1400" dirty="0"/>
              <a:t>-Scoring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/>
              <a:t>Diagnostic accuracy of quantitative SPECT/CT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1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variabl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400" dirty="0"/>
              <a:t>SUVmax, </a:t>
            </a:r>
            <a:r>
              <a:rPr lang="en-US" altLang="en-US" sz="1400" dirty="0" err="1"/>
              <a:t>Perugini</a:t>
            </a:r>
            <a:r>
              <a:rPr lang="en-US" altLang="en-US" sz="1400" dirty="0"/>
              <a:t>-Score, Amyloidosis </a:t>
            </a:r>
            <a:r>
              <a:rPr lang="en-US" altLang="en-US" sz="1400" dirty="0" err="1"/>
              <a:t>subtyp</a:t>
            </a:r>
            <a:endParaRPr lang="en-US" altLang="en-US" sz="1400" dirty="0"/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CC1CE73C-A76F-41B5-904C-089872EF91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5146" y="1624946"/>
            <a:ext cx="6206490" cy="3324860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5C13ECB9-1AAF-4CF2-B89E-96C861C261C2}"/>
              </a:ext>
            </a:extLst>
          </p:cNvPr>
          <p:cNvSpPr txBox="1"/>
          <p:nvPr/>
        </p:nvSpPr>
        <p:spPr>
          <a:xfrm>
            <a:off x="972364" y="4856946"/>
            <a:ext cx="75438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uantitative tracer uptake was measured in a freehand VOI of the heart and spherical VOIs in the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oodpool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a vertebral bone. Calculated SUVmax shows significantly increase tracer uptake in the heart with increasing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ugini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core. Furthermore, a decrease of bone tracer uptake could be observed in patients with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ugini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core 2 and 3. *p&lt;0.05; ****p&lt;0.0001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id="{3B59E345-B626-4A56-B979-A71F47D4936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800" y="1732805"/>
            <a:ext cx="7848600" cy="2141708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14ABEB31-6E25-4E61-8DFA-46341ABA282D}"/>
              </a:ext>
            </a:extLst>
          </p:cNvPr>
          <p:cNvSpPr txBox="1"/>
          <p:nvPr/>
        </p:nvSpPr>
        <p:spPr>
          <a:xfrm>
            <a:off x="990600" y="4343400"/>
            <a:ext cx="7239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atter-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gramms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how a linear relationship between the visual 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ugini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core and tracer uptake parameters (</a:t>
            </a: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-C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earmans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’ r shows strong correlation for all parameters.</a:t>
            </a:r>
            <a:endParaRPr lang="de-DE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We demonstrate an accessible and accurate quantitative SPECT approach in CA. 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2- Quantitative assessment of the cardiac tracer uptake may improve diagnostic accuracy and risk classification. 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3-This method may enable monitoring and assessment of therapy response in patients with ATTR-amyloidosis</a:t>
            </a:r>
            <a:r>
              <a:rPr lang="en-US" altLang="en-US" sz="3600" dirty="0"/>
              <a:t>.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98872" y="6366463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486</Words>
  <Application>Microsoft Office PowerPoint</Application>
  <PresentationFormat>Bildschirmpräsentation (4:3)</PresentationFormat>
  <Paragraphs>57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Quantitative 99mTc-DPD-SPECT/CT assessment of cardiac amyloidosi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Lukas Kessler</cp:lastModifiedBy>
  <cp:revision>104</cp:revision>
  <dcterms:created xsi:type="dcterms:W3CDTF">2011-04-18T21:44:13Z</dcterms:created>
  <dcterms:modified xsi:type="dcterms:W3CDTF">2022-02-05T15:35:03Z</dcterms:modified>
</cp:coreProperties>
</file>